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48908-BDE3-43A4-AB76-866E695EE5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E638D-5224-4D68-B618-F2D005A382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B0B78-A32E-4DFA-8A0B-E1ED6C0620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6796C-54C5-4ACA-8527-30273E6F97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977EB-3EDB-4A67-8890-55C93E93D5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DA58A-56F9-42C3-8162-50F558E5E5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82F98-FCBD-4900-A9FA-61E0C16822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8B85C-C281-4E28-9E9F-EAA251CF74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8F99F-943D-4197-B42A-433B9A28E6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A8D28-C957-4F47-BDF8-5884BFB09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9E779-14A3-4756-880A-EED106EB4C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A11A8-E7D0-4A30-8274-9BF89F94C4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5BE7BC-ACB9-433A-8A33-CA81EAEF476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080" y="0"/>
            <a:ext cx="240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data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28600" y="838080"/>
            <a:ext cx="3966480" cy="2240280"/>
            <a:chOff x="228600" y="838080"/>
            <a:chExt cx="3966480" cy="2240280"/>
          </a:xfrm>
        </p:grpSpPr>
        <p:grpSp>
          <p:nvGrpSpPr>
            <p:cNvPr id="43" name=""/>
            <p:cNvGrpSpPr/>
            <p:nvPr/>
          </p:nvGrpSpPr>
          <p:grpSpPr>
            <a:xfrm>
              <a:off x="1001880" y="1493280"/>
              <a:ext cx="207720" cy="1368360"/>
              <a:chOff x="1001880" y="1493280"/>
              <a:chExt cx="207720" cy="1368360"/>
            </a:xfrm>
          </p:grpSpPr>
          <p:sp>
            <p:nvSpPr>
              <p:cNvPr id="44" name=""/>
              <p:cNvSpPr/>
              <p:nvPr/>
            </p:nvSpPr>
            <p:spPr>
              <a:xfrm>
                <a:off x="1001880" y="1869120"/>
                <a:ext cx="207720" cy="9925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 flipV="1">
                <a:off x="1103040" y="1493280"/>
                <a:ext cx="720" cy="375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090440" y="1493640"/>
                <a:ext cx="295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7" name=""/>
            <p:cNvGrpSpPr/>
            <p:nvPr/>
          </p:nvGrpSpPr>
          <p:grpSpPr>
            <a:xfrm>
              <a:off x="1576440" y="2079000"/>
              <a:ext cx="255600" cy="782640"/>
              <a:chOff x="1576440" y="2079000"/>
              <a:chExt cx="255600" cy="782640"/>
            </a:xfrm>
          </p:grpSpPr>
          <p:sp>
            <p:nvSpPr>
              <p:cNvPr id="48" name=""/>
              <p:cNvSpPr/>
              <p:nvPr/>
            </p:nvSpPr>
            <p:spPr>
              <a:xfrm>
                <a:off x="1576440" y="2188440"/>
                <a:ext cx="255600" cy="6732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 flipV="1">
                <a:off x="1703880" y="2079000"/>
                <a:ext cx="1080" cy="109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688400" y="2079360"/>
                <a:ext cx="3708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"/>
            <p:cNvSpPr/>
            <p:nvPr/>
          </p:nvSpPr>
          <p:spPr>
            <a:xfrm>
              <a:off x="790560" y="1349280"/>
              <a:ext cx="1440" cy="1512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57080" y="2862000"/>
              <a:ext cx="33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57080" y="2489040"/>
              <a:ext cx="33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757080" y="2112840"/>
              <a:ext cx="33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57080" y="1725480"/>
              <a:ext cx="33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57080" y="1349280"/>
              <a:ext cx="33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790560" y="2861640"/>
              <a:ext cx="1440" cy="57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61320" y="27637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47120" y="238896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17680" y="2012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47120" y="16268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17680" y="12506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860400" y="2895480"/>
              <a:ext cx="55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laceb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485720" y="2895480"/>
              <a:ext cx="610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-TN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28600" y="988920"/>
              <a:ext cx="2225520" cy="54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2800" rIns="82800" tIns="41400" bIns="414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Lymphatic vessel are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751"/>
                </a:spcBef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mm</a:t>
              </a:r>
              <a:r>
                <a:rPr b="0" lang="en-US" sz="1200" spc="-1" strike="noStrike" baseline="30000">
                  <a:solidFill>
                    <a:srgbClr val="ffffff"/>
                  </a:solidFill>
                  <a:latin typeface="Arial"/>
                </a:rPr>
                <a:t>2</a:t>
              </a: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/mm</a:t>
              </a:r>
              <a:r>
                <a:rPr b="0" lang="en-US" sz="1200" spc="-1" strike="noStrike" baseline="30000">
                  <a:solidFill>
                    <a:srgbClr val="ffffff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795240" y="2862000"/>
              <a:ext cx="1174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384640" y="1004760"/>
              <a:ext cx="181044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800" rIns="82800" tIns="41400" bIns="414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Lymphatic vessel #/mm</a:t>
              </a:r>
              <a:r>
                <a:rPr b="0" lang="en-US" sz="1200" spc="-1" strike="noStrike" baseline="30000">
                  <a:solidFill>
                    <a:srgbClr val="ffffff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"/>
            <p:cNvGrpSpPr/>
            <p:nvPr/>
          </p:nvGrpSpPr>
          <p:grpSpPr>
            <a:xfrm>
              <a:off x="2919240" y="1490400"/>
              <a:ext cx="227160" cy="1353960"/>
              <a:chOff x="2919240" y="1490400"/>
              <a:chExt cx="227160" cy="1353960"/>
            </a:xfrm>
          </p:grpSpPr>
          <p:sp>
            <p:nvSpPr>
              <p:cNvPr id="69" name=""/>
              <p:cNvSpPr/>
              <p:nvPr/>
            </p:nvSpPr>
            <p:spPr>
              <a:xfrm>
                <a:off x="2919240" y="1787040"/>
                <a:ext cx="227160" cy="10573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3031200" y="1490400"/>
                <a:ext cx="720" cy="296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021480" y="1490400"/>
                <a:ext cx="2196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" name=""/>
            <p:cNvGrpSpPr/>
            <p:nvPr/>
          </p:nvGrpSpPr>
          <p:grpSpPr>
            <a:xfrm>
              <a:off x="3560760" y="1645920"/>
              <a:ext cx="208080" cy="1198440"/>
              <a:chOff x="3560760" y="1645920"/>
              <a:chExt cx="208080" cy="1198440"/>
            </a:xfrm>
          </p:grpSpPr>
          <p:sp>
            <p:nvSpPr>
              <p:cNvPr id="73" name=""/>
              <p:cNvSpPr/>
              <p:nvPr/>
            </p:nvSpPr>
            <p:spPr>
              <a:xfrm>
                <a:off x="3560760" y="1853280"/>
                <a:ext cx="208080" cy="99108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V="1">
                <a:off x="3663360" y="1645920"/>
                <a:ext cx="1080" cy="207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654720" y="1645920"/>
                <a:ext cx="20880" cy="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"/>
            <p:cNvSpPr/>
            <p:nvPr/>
          </p:nvSpPr>
          <p:spPr>
            <a:xfrm>
              <a:off x="2687760" y="1360080"/>
              <a:ext cx="1440" cy="148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665440" y="284472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665440" y="263340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665440" y="2414520"/>
              <a:ext cx="22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665440" y="220644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665440" y="199692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665440" y="178740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665440" y="1568160"/>
              <a:ext cx="22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665440" y="1360080"/>
              <a:ext cx="22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2687760" y="2844360"/>
              <a:ext cx="14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47000" y="2742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452680" y="2536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452680" y="23176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452680" y="2104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452680" y="18982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382480" y="16905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382480" y="14713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382480" y="12603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865600" y="2895480"/>
              <a:ext cx="55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laceb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490560" y="2895480"/>
              <a:ext cx="610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-TN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662200" y="2844720"/>
              <a:ext cx="124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90600" y="838080"/>
              <a:ext cx="164880" cy="264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800" rIns="82800" tIns="41400" bIns="41400" anchor="t">
              <a:spAutoFit/>
            </a:bodyPr>
            <a:p>
              <a:pPr>
                <a:tabLst>
                  <a:tab algn="l" pos="0"/>
                  <a:tab algn="l" pos="828720"/>
                  <a:tab algn="l" pos="1657440"/>
                  <a:tab algn="l" pos="2486160"/>
                  <a:tab algn="l" pos="3314880"/>
                  <a:tab algn="l" pos="4143240"/>
                  <a:tab algn="l" pos="4971960"/>
                  <a:tab algn="l" pos="5800680"/>
                  <a:tab algn="l" pos="6629400"/>
                  <a:tab algn="l" pos="7458120"/>
                  <a:tab algn="l" pos="8286840"/>
                  <a:tab algn="l" pos="9115560"/>
                  <a:tab algn="l" pos="9944280"/>
                  <a:tab algn="l" pos="107726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8" name=""/>
          <p:cNvGrpSpPr/>
          <p:nvPr/>
        </p:nvGrpSpPr>
        <p:grpSpPr>
          <a:xfrm>
            <a:off x="4725360" y="1066680"/>
            <a:ext cx="1669320" cy="2051280"/>
            <a:chOff x="4725360" y="1066680"/>
            <a:chExt cx="1669320" cy="2051280"/>
          </a:xfrm>
        </p:grpSpPr>
        <p:sp>
          <p:nvSpPr>
            <p:cNvPr id="99" name=""/>
            <p:cNvSpPr/>
            <p:nvPr/>
          </p:nvSpPr>
          <p:spPr>
            <a:xfrm>
              <a:off x="5638680" y="2584800"/>
              <a:ext cx="266760" cy="278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029200" y="1632600"/>
              <a:ext cx="263520" cy="1230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5771880" y="2503800"/>
              <a:ext cx="0" cy="80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762520" y="2503800"/>
              <a:ext cx="223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5159160" y="1452240"/>
              <a:ext cx="0" cy="179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149800" y="1452600"/>
              <a:ext cx="22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895640" y="1362960"/>
              <a:ext cx="1800" cy="150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857480" y="2863080"/>
              <a:ext cx="381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857480" y="269280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857480" y="2530800"/>
              <a:ext cx="381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857480" y="236016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857480" y="2198160"/>
              <a:ext cx="381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857480" y="202788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857480" y="1865880"/>
              <a:ext cx="381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857480" y="169524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857480" y="153360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857480" y="1362960"/>
              <a:ext cx="38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895640" y="2863080"/>
              <a:ext cx="1047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V="1">
              <a:off x="4895640" y="2862720"/>
              <a:ext cx="180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732920" y="27914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732920" y="26208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732920" y="24573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732920" y="22881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732920" y="21265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732920" y="1955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732920" y="17942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732920" y="16232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732920" y="14616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732920" y="12909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562360" y="2935080"/>
              <a:ext cx="610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-TN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949640" y="2935080"/>
              <a:ext cx="55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laceb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725360" y="1066680"/>
              <a:ext cx="166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flammation area (mm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"/>
          <p:cNvSpPr/>
          <p:nvPr/>
        </p:nvSpPr>
        <p:spPr>
          <a:xfrm>
            <a:off x="5624640" y="22240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3T17:43:23Z</dcterms:created>
  <dc:creator>lxing</dc:creator>
  <dc:description/>
  <dc:language>en-US</dc:language>
  <cp:lastModifiedBy>Claire.Owen</cp:lastModifiedBy>
  <dcterms:modified xsi:type="dcterms:W3CDTF">2007-11-06T17:01:22Z</dcterms:modified>
  <cp:revision>415</cp:revision>
  <dc:subject/>
  <dc:title>Slide 1</dc:title>
</cp:coreProperties>
</file>